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tif" ContentType="image/tiff"/>
  <Override PartName="/ppt/media/image6.tif" ContentType="image/tif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12193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EC8380-DC5C-4190-967A-D0A3C0BAA6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488520"/>
            <a:ext cx="6172200" cy="203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844360"/>
            <a:ext cx="617220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7047720"/>
            <a:ext cx="617220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CBA18E-3B80-48CB-B39A-5C13186153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488520"/>
            <a:ext cx="6172200" cy="203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844360"/>
            <a:ext cx="301176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844360"/>
            <a:ext cx="301176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7047720"/>
            <a:ext cx="301176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7047720"/>
            <a:ext cx="301176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33D3E-6AA5-4803-A613-5D9DC4CF2A9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488520"/>
            <a:ext cx="6172200" cy="203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844360"/>
            <a:ext cx="198720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844360"/>
            <a:ext cx="198720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844360"/>
            <a:ext cx="198720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7047720"/>
            <a:ext cx="198720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7047720"/>
            <a:ext cx="198720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7047720"/>
            <a:ext cx="198720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C04205-3FE4-44F7-8D55-EF7EF8961B6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488520"/>
            <a:ext cx="6172200" cy="203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844360"/>
            <a:ext cx="6172200" cy="8047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5FD3D1-BA7D-40E4-8E0E-3CAB6480DB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488520"/>
            <a:ext cx="6172200" cy="203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844360"/>
            <a:ext cx="6172200" cy="804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0DE8B6-C185-450B-A2FE-25E2415040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488520"/>
            <a:ext cx="6172200" cy="203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844360"/>
            <a:ext cx="3011760" cy="804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844360"/>
            <a:ext cx="3011760" cy="804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9D50B-18D8-4F6A-971E-5D394DD27C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488520"/>
            <a:ext cx="6172200" cy="203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F08B1F-5E95-4FFA-BD12-6B7C8CABBD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488520"/>
            <a:ext cx="6172200" cy="942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B597F-8D88-4AF2-9B65-54CE56B0BA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488520"/>
            <a:ext cx="6172200" cy="203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844360"/>
            <a:ext cx="301176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844360"/>
            <a:ext cx="3011760" cy="804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7047720"/>
            <a:ext cx="301176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93F393-4871-43A2-A575-292BB4DAC1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488520"/>
            <a:ext cx="6172200" cy="203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844360"/>
            <a:ext cx="3011760" cy="804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844360"/>
            <a:ext cx="301176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7047720"/>
            <a:ext cx="301176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A6730-8787-48F3-BDBA-A969311D19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488520"/>
            <a:ext cx="6172200" cy="203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844360"/>
            <a:ext cx="301176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844360"/>
            <a:ext cx="301176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7047720"/>
            <a:ext cx="6172200" cy="383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38A05E-1AAB-480D-B545-5A1984FA85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488520"/>
            <a:ext cx="6172200" cy="203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844360"/>
            <a:ext cx="6172200" cy="804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7040" indent="-2570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34272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68580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028880" indent="-34308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11103120"/>
            <a:ext cx="1600200" cy="84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11103120"/>
            <a:ext cx="2171520" cy="84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11103120"/>
            <a:ext cx="1600200" cy="84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3F1C16-4873-4414-B284-23B9BB0E58E6}" type="slidenum">
              <a:rPr b="0" lang="zh-CN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tif"/><Relationship Id="rId6" Type="http://schemas.openxmlformats.org/officeDocument/2006/relationships/image" Target="../media/image6.ti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7"/>
          <p:cNvSpPr/>
          <p:nvPr/>
        </p:nvSpPr>
        <p:spPr>
          <a:xfrm>
            <a:off x="1168560" y="239760"/>
            <a:ext cx="258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rogression-free surviv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文本框 8"/>
          <p:cNvSpPr/>
          <p:nvPr/>
        </p:nvSpPr>
        <p:spPr>
          <a:xfrm>
            <a:off x="3322800" y="239760"/>
            <a:ext cx="2584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Overall surviv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文本框 9"/>
          <p:cNvSpPr/>
          <p:nvPr/>
        </p:nvSpPr>
        <p:spPr>
          <a:xfrm>
            <a:off x="981000" y="2654280"/>
            <a:ext cx="2379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bscopal response r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文本框 10"/>
          <p:cNvSpPr/>
          <p:nvPr/>
        </p:nvSpPr>
        <p:spPr>
          <a:xfrm>
            <a:off x="3552840" y="2637000"/>
            <a:ext cx="244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bscopal control r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文本框 11"/>
          <p:cNvSpPr/>
          <p:nvPr/>
        </p:nvSpPr>
        <p:spPr>
          <a:xfrm>
            <a:off x="1197000" y="7388280"/>
            <a:ext cx="449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Fig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ure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2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. Egger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’ 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 test of publication bia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文本框 9"/>
          <p:cNvSpPr/>
          <p:nvPr/>
        </p:nvSpPr>
        <p:spPr>
          <a:xfrm>
            <a:off x="1197000" y="5041800"/>
            <a:ext cx="206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dverse events r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文本框 10"/>
          <p:cNvSpPr/>
          <p:nvPr/>
        </p:nvSpPr>
        <p:spPr>
          <a:xfrm>
            <a:off x="3627360" y="5041800"/>
            <a:ext cx="2062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neumonitis r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图片 9" descr="不良反应率egger"/>
          <p:cNvPicPr/>
          <p:nvPr/>
        </p:nvPicPr>
        <p:blipFill>
          <a:blip r:embed="rId1"/>
          <a:stretch/>
        </p:blipFill>
        <p:spPr>
          <a:xfrm>
            <a:off x="727200" y="5361120"/>
            <a:ext cx="2593800" cy="1888920"/>
          </a:xfrm>
          <a:prstGeom prst="rect">
            <a:avLst/>
          </a:prstGeom>
          <a:ln w="0">
            <a:noFill/>
          </a:ln>
        </p:spPr>
      </p:pic>
      <p:pic>
        <p:nvPicPr>
          <p:cNvPr id="49" name="图片 10" descr="肺炎egger"/>
          <p:cNvPicPr/>
          <p:nvPr/>
        </p:nvPicPr>
        <p:blipFill>
          <a:blip r:embed="rId2"/>
          <a:stretch/>
        </p:blipFill>
        <p:spPr>
          <a:xfrm>
            <a:off x="3429000" y="5302080"/>
            <a:ext cx="2701800" cy="1967040"/>
          </a:xfrm>
          <a:prstGeom prst="rect">
            <a:avLst/>
          </a:prstGeom>
          <a:ln w="0">
            <a:noFill/>
          </a:ln>
        </p:spPr>
      </p:pic>
      <p:pic>
        <p:nvPicPr>
          <p:cNvPr id="50" name="图片 9" descr=""/>
          <p:cNvPicPr/>
          <p:nvPr/>
        </p:nvPicPr>
        <p:blipFill>
          <a:blip r:embed="rId3"/>
          <a:stretch/>
        </p:blipFill>
        <p:spPr>
          <a:xfrm>
            <a:off x="797040" y="3048120"/>
            <a:ext cx="2522520" cy="2052360"/>
          </a:xfrm>
          <a:prstGeom prst="rect">
            <a:avLst/>
          </a:prstGeom>
          <a:ln w="0">
            <a:noFill/>
          </a:ln>
        </p:spPr>
      </p:pic>
      <p:pic>
        <p:nvPicPr>
          <p:cNvPr id="51" name="图片 9" descr=""/>
          <p:cNvPicPr/>
          <p:nvPr/>
        </p:nvPicPr>
        <p:blipFill>
          <a:blip r:embed="rId4"/>
          <a:stretch/>
        </p:blipFill>
        <p:spPr>
          <a:xfrm>
            <a:off x="797040" y="608040"/>
            <a:ext cx="2563560" cy="2003400"/>
          </a:xfrm>
          <a:prstGeom prst="rect">
            <a:avLst/>
          </a:prstGeom>
          <a:ln w="0">
            <a:noFill/>
          </a:ln>
        </p:spPr>
      </p:pic>
      <p:pic>
        <p:nvPicPr>
          <p:cNvPr id="52" name="图片 1" descr="egger图"/>
          <p:cNvPicPr/>
          <p:nvPr/>
        </p:nvPicPr>
        <p:blipFill>
          <a:blip r:embed="rId5"/>
          <a:stretch/>
        </p:blipFill>
        <p:spPr>
          <a:xfrm>
            <a:off x="3500280" y="3048120"/>
            <a:ext cx="2630520" cy="2052360"/>
          </a:xfrm>
          <a:prstGeom prst="rect">
            <a:avLst/>
          </a:prstGeom>
          <a:ln w="0">
            <a:noFill/>
          </a:ln>
        </p:spPr>
      </p:pic>
      <p:pic>
        <p:nvPicPr>
          <p:cNvPr id="53" name="图片 2" descr="egger分析"/>
          <p:cNvPicPr/>
          <p:nvPr/>
        </p:nvPicPr>
        <p:blipFill>
          <a:blip r:embed="rId6"/>
          <a:stretch/>
        </p:blipFill>
        <p:spPr>
          <a:xfrm>
            <a:off x="3500280" y="608040"/>
            <a:ext cx="2630520" cy="2011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7-07T06:12:51Z</dcterms:created>
  <dc:creator>LIU</dc:creator>
  <dc:description/>
  <dc:language>en-US</dc:language>
  <cp:lastModifiedBy>子靖</cp:lastModifiedBy>
  <dcterms:modified xsi:type="dcterms:W3CDTF">2023-01-07T14:30:29Z</dcterms:modified>
  <cp:revision>8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2C96FE38B7D4FB993B3DA10F1277C07</vt:lpwstr>
  </property>
  <property fmtid="{D5CDD505-2E9C-101B-9397-08002B2CF9AE}" pid="3" name="KSOProductBuildVer">
    <vt:lpwstr>2052-11.1.0.13703</vt:lpwstr>
  </property>
</Properties>
</file>